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  <Override PartName="/ppt/charts/colors2.xml" ContentType="application/vnd.ms-office.chartcolorstyle+xml"/>
  <Override PartName="/ppt/charts/style2.xml" ContentType="application/vnd.ms-office.chartstyle+xml"/>
  <Override PartName="/ppt/charts/colors3.xml" ContentType="application/vnd.ms-office.chartcolorstyle+xml"/>
  <Override PartName="/ppt/charts/style3.xml" ContentType="application/vnd.ms-office.chartstyle+xml"/>
  <Override PartName="/ppt/charts/colors4.xml" ContentType="application/vnd.ms-office.chartcolorstyle+xml"/>
  <Override PartName="/ppt/charts/style4.xml" ContentType="application/vnd.ms-office.chartstyle+xml"/>
  <Override PartName="/ppt/charts/colors5.xml" ContentType="application/vnd.ms-office.chartcolorstyle+xml"/>
  <Override PartName="/ppt/charts/style5.xml" ContentType="application/vnd.ms-office.chartstyle+xml"/>
  <Override PartName="/ppt/charts/colors6.xml" ContentType="application/vnd.ms-office.chartcolorstyle+xml"/>
  <Override PartName="/ppt/charts/style6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ar-SA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0" d="100"/>
          <a:sy n="60" d="100"/>
        </p:scale>
        <p:origin x="-1080" y="-22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Relationship Id="rId4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2.xml"/><Relationship Id="rId4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openxmlformats.org/officeDocument/2006/relationships/package" Target="../embeddings/Microsoft_Excel_Worksheet3.xlsx"/><Relationship Id="rId1" Type="http://schemas.openxmlformats.org/officeDocument/2006/relationships/themeOverride" Target="../theme/themeOverride3.xml"/><Relationship Id="rId4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openxmlformats.org/officeDocument/2006/relationships/package" Target="../embeddings/Microsoft_Excel_Worksheet4.xlsx"/><Relationship Id="rId1" Type="http://schemas.openxmlformats.org/officeDocument/2006/relationships/themeOverride" Target="../theme/themeOverride4.xml"/><Relationship Id="rId4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ColorStyle" Target="colors5.xml"/><Relationship Id="rId2" Type="http://schemas.openxmlformats.org/officeDocument/2006/relationships/package" Target="../embeddings/Microsoft_Excel_Worksheet5.xlsx"/><Relationship Id="rId1" Type="http://schemas.openxmlformats.org/officeDocument/2006/relationships/themeOverride" Target="../theme/themeOverride5.xml"/><Relationship Id="rId4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ColorStyle" Target="colors6.xml"/><Relationship Id="rId2" Type="http://schemas.openxmlformats.org/officeDocument/2006/relationships/package" Target="../embeddings/Microsoft_Excel_Worksheet6.xlsx"/><Relationship Id="rId1" Type="http://schemas.openxmlformats.org/officeDocument/2006/relationships/themeOverride" Target="../theme/themeOverride6.xml"/><Relationship Id="rId4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ar-EG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b="1" i="1" dirty="0">
                <a:solidFill>
                  <a:schemeClr val="tx1"/>
                </a:solidFill>
              </a:rPr>
              <a:t>C. </a:t>
            </a:r>
            <a:r>
              <a:rPr lang="en-US" altLang="ja-JP" b="1" i="1" dirty="0" err="1">
                <a:solidFill>
                  <a:schemeClr val="tx1"/>
                </a:solidFill>
              </a:rPr>
              <a:t>harengus</a:t>
            </a:r>
            <a:endParaRPr lang="en-US" altLang="ja-JP" b="1" i="1" dirty="0">
              <a:solidFill>
                <a:schemeClr val="tx1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view3D>
      <c:rotX val="30"/>
      <c:rotY val="360"/>
      <c:depthPercent val="100"/>
      <c:rAngAx val="0"/>
      <c:perspective val="3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pie3DChart>
        <c:varyColors val="1"/>
        <c:ser>
          <c:idx val="0"/>
          <c:order val="0"/>
          <c:tx>
            <c:strRef>
              <c:f>ورقة1!$A$27</c:f>
              <c:strCache>
                <c:ptCount val="1"/>
                <c:pt idx="0">
                  <c:v>C. harengus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6BBC-4054-AA67-DC98C0E1EB99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6BBC-4054-AA67-DC98C0E1EB99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6BBC-4054-AA67-DC98C0E1EB99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6BBC-4054-AA67-DC98C0E1EB99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6BBC-4054-AA67-DC98C0E1EB99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6BBC-4054-AA67-DC98C0E1EB99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ar-EG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 xmlns:c16r2="http://schemas.microsoft.com/office/drawing/2015/06/chart">
              <c:ext xmlns:c15="http://schemas.microsoft.com/office/drawing/2012/chart" uri="{CE6537A1-D6FC-4f65-9D91-7224C49458BB}"/>
            </c:extLst>
          </c:dLbls>
          <c:cat>
            <c:strRef>
              <c:f>ورقة1!$B$26:$G$26</c:f>
              <c:strCache>
                <c:ptCount val="6"/>
                <c:pt idx="0">
                  <c:v>∑HCH</c:v>
                </c:pt>
                <c:pt idx="1">
                  <c:v>HCB</c:v>
                </c:pt>
                <c:pt idx="2">
                  <c:v>∑HPTs</c:v>
                </c:pt>
                <c:pt idx="3">
                  <c:v>∑DRINs</c:v>
                </c:pt>
                <c:pt idx="4">
                  <c:v>∑CHLRs</c:v>
                </c:pt>
                <c:pt idx="5">
                  <c:v>∑DDTs</c:v>
                </c:pt>
              </c:strCache>
            </c:strRef>
          </c:cat>
          <c:val>
            <c:numRef>
              <c:f>ورقة1!$B$27:$G$27</c:f>
              <c:numCache>
                <c:formatCode>0.00</c:formatCode>
                <c:ptCount val="6"/>
                <c:pt idx="0">
                  <c:v>25.085954412326501</c:v>
                </c:pt>
                <c:pt idx="1">
                  <c:v>2.5849993633006494</c:v>
                </c:pt>
                <c:pt idx="2">
                  <c:v>12.975932764548578</c:v>
                </c:pt>
                <c:pt idx="3">
                  <c:v>10.963962816757926</c:v>
                </c:pt>
                <c:pt idx="4">
                  <c:v>25.149624347383163</c:v>
                </c:pt>
                <c:pt idx="5">
                  <c:v>23.23952629568317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C-6BBC-4054-AA67-DC98C0E1EB99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</c:pie3DChart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ar-EG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ar-EG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ar-EG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b="1" i="1" dirty="0">
                <a:solidFill>
                  <a:schemeClr val="tx1"/>
                </a:solidFill>
              </a:rPr>
              <a:t>T. </a:t>
            </a:r>
            <a:r>
              <a:rPr lang="en-US" altLang="ja-JP" b="1" i="1" dirty="0" err="1">
                <a:solidFill>
                  <a:schemeClr val="tx1"/>
                </a:solidFill>
              </a:rPr>
              <a:t>nilotica</a:t>
            </a:r>
            <a:endParaRPr lang="en-US" altLang="ja-JP" b="1" i="1" dirty="0">
              <a:solidFill>
                <a:schemeClr val="tx1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view3D>
      <c:rotX val="30"/>
      <c:rotY val="360"/>
      <c:depthPercent val="100"/>
      <c:rAngAx val="0"/>
      <c:perspective val="3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pie3DChart>
        <c:varyColors val="1"/>
        <c:ser>
          <c:idx val="0"/>
          <c:order val="0"/>
          <c:tx>
            <c:strRef>
              <c:f>ورقة1!$A$36</c:f>
              <c:strCache>
                <c:ptCount val="1"/>
                <c:pt idx="0">
                  <c:v>T. nilotica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9FC1-4FF4-9DD4-1ACFCB982AEC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9FC1-4FF4-9DD4-1ACFCB982AEC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9FC1-4FF4-9DD4-1ACFCB982AEC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9FC1-4FF4-9DD4-1ACFCB982AEC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9FC1-4FF4-9DD4-1ACFCB982AEC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9FC1-4FF4-9DD4-1ACFCB982AEC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ar-EG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 xmlns:c16r2="http://schemas.microsoft.com/office/drawing/2015/06/chart">
              <c:ext xmlns:c15="http://schemas.microsoft.com/office/drawing/2012/chart" uri="{CE6537A1-D6FC-4f65-9D91-7224C49458BB}"/>
            </c:extLst>
          </c:dLbls>
          <c:cat>
            <c:strRef>
              <c:f>ورقة1!$B$35:$G$35</c:f>
              <c:strCache>
                <c:ptCount val="6"/>
                <c:pt idx="0">
                  <c:v>∑HCH</c:v>
                </c:pt>
                <c:pt idx="1">
                  <c:v>HCB</c:v>
                </c:pt>
                <c:pt idx="2">
                  <c:v>∑HPTs</c:v>
                </c:pt>
                <c:pt idx="3">
                  <c:v>∑DRINs</c:v>
                </c:pt>
                <c:pt idx="4">
                  <c:v>∑CHLRs</c:v>
                </c:pt>
                <c:pt idx="5">
                  <c:v> ∑DDTs</c:v>
                </c:pt>
              </c:strCache>
            </c:strRef>
          </c:cat>
          <c:val>
            <c:numRef>
              <c:f>ورقة1!$B$36:$G$36</c:f>
              <c:numCache>
                <c:formatCode>0.00</c:formatCode>
                <c:ptCount val="6"/>
                <c:pt idx="0">
                  <c:v>28.819875776397513</c:v>
                </c:pt>
                <c:pt idx="1">
                  <c:v>4.3478260869565206</c:v>
                </c:pt>
                <c:pt idx="2">
                  <c:v>11.801242236024843</c:v>
                </c:pt>
                <c:pt idx="3">
                  <c:v>17.763975155279503</c:v>
                </c:pt>
                <c:pt idx="4">
                  <c:v>18.757763975155278</c:v>
                </c:pt>
                <c:pt idx="5">
                  <c:v>18.50931677018633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C-9FC1-4FF4-9DD4-1ACFCB982A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</c:pie3DChart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ar-EG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ar-EG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ar-EG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b="1" i="1" dirty="0">
                <a:solidFill>
                  <a:schemeClr val="tx1"/>
                </a:solidFill>
              </a:rPr>
              <a:t>S. </a:t>
            </a:r>
            <a:r>
              <a:rPr lang="en-US" altLang="ja-JP" b="1" i="1" dirty="0" err="1">
                <a:solidFill>
                  <a:schemeClr val="tx1"/>
                </a:solidFill>
              </a:rPr>
              <a:t>savigngi</a:t>
            </a:r>
            <a:endParaRPr lang="en-US" altLang="ja-JP" b="1" i="1" dirty="0">
              <a:solidFill>
                <a:schemeClr val="tx1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view3D>
      <c:rotX val="30"/>
      <c:rotY val="360"/>
      <c:depthPercent val="100"/>
      <c:rAngAx val="0"/>
      <c:perspective val="3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pie3DChart>
        <c:varyColors val="1"/>
        <c:ser>
          <c:idx val="0"/>
          <c:order val="0"/>
          <c:tx>
            <c:strRef>
              <c:f>ورقة1!$A$42</c:f>
              <c:strCache>
                <c:ptCount val="1"/>
                <c:pt idx="0">
                  <c:v>S. savigngi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451C-4866-AEA4-927B0BCFC867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451C-4866-AEA4-927B0BCFC867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451C-4866-AEA4-927B0BCFC867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451C-4866-AEA4-927B0BCFC867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451C-4866-AEA4-927B0BCFC867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451C-4866-AEA4-927B0BCFC867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ar-EG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 xmlns:c16r2="http://schemas.microsoft.com/office/drawing/2015/06/chart">
              <c:ext xmlns:c15="http://schemas.microsoft.com/office/drawing/2012/chart" uri="{CE6537A1-D6FC-4f65-9D91-7224C49458BB}"/>
            </c:extLst>
          </c:dLbls>
          <c:cat>
            <c:strRef>
              <c:f>ورقة1!$B$41:$G$41</c:f>
              <c:strCache>
                <c:ptCount val="6"/>
                <c:pt idx="0">
                  <c:v>∑HCH</c:v>
                </c:pt>
                <c:pt idx="1">
                  <c:v>HCB</c:v>
                </c:pt>
                <c:pt idx="2">
                  <c:v>∑HPTs</c:v>
                </c:pt>
                <c:pt idx="3">
                  <c:v>∑DRINs</c:v>
                </c:pt>
                <c:pt idx="4">
                  <c:v>∑CHLRs</c:v>
                </c:pt>
                <c:pt idx="5">
                  <c:v> ∑DDTs</c:v>
                </c:pt>
              </c:strCache>
            </c:strRef>
          </c:cat>
          <c:val>
            <c:numRef>
              <c:f>ورقة1!$B$42:$G$42</c:f>
              <c:numCache>
                <c:formatCode>0.00</c:formatCode>
                <c:ptCount val="6"/>
                <c:pt idx="0">
                  <c:v>46.129032258064512</c:v>
                </c:pt>
                <c:pt idx="1">
                  <c:v>5.8064516129032251</c:v>
                </c:pt>
                <c:pt idx="2">
                  <c:v>10.32258064516129</c:v>
                </c:pt>
                <c:pt idx="3">
                  <c:v>0</c:v>
                </c:pt>
                <c:pt idx="4">
                  <c:v>26.451612903225801</c:v>
                </c:pt>
                <c:pt idx="5">
                  <c:v>11.2903225806451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C-451C-4866-AEA4-927B0BCFC867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</c:pie3DChart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ar-EG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ar-EG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ar-EG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b="1" i="1" dirty="0">
                <a:solidFill>
                  <a:schemeClr val="tx1"/>
                </a:solidFill>
              </a:rPr>
              <a:t>N. </a:t>
            </a:r>
            <a:r>
              <a:rPr lang="en-US" altLang="ja-JP" b="1" i="1" dirty="0" err="1">
                <a:solidFill>
                  <a:schemeClr val="tx1"/>
                </a:solidFill>
              </a:rPr>
              <a:t>pelagicus</a:t>
            </a:r>
            <a:endParaRPr lang="en-US" altLang="ja-JP" b="1" i="1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39648600174978127"/>
          <c:y val="1.8518518518518517E-2"/>
        </c:manualLayout>
      </c:layout>
      <c:overlay val="0"/>
      <c:spPr>
        <a:noFill/>
        <a:ln>
          <a:noFill/>
        </a:ln>
        <a:effectLst/>
      </c:spPr>
    </c:title>
    <c:autoTitleDeleted val="0"/>
    <c:view3D>
      <c:rotX val="30"/>
      <c:rotY val="360"/>
      <c:depthPercent val="100"/>
      <c:rAngAx val="0"/>
      <c:perspective val="3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pie3DChart>
        <c:varyColors val="1"/>
        <c:ser>
          <c:idx val="0"/>
          <c:order val="0"/>
          <c:tx>
            <c:strRef>
              <c:f>ورقة1!$A$39</c:f>
              <c:strCache>
                <c:ptCount val="1"/>
                <c:pt idx="0">
                  <c:v>N. pelagicus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D45E-44F1-8D2B-7A21A38CA088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D45E-44F1-8D2B-7A21A38CA088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D45E-44F1-8D2B-7A21A38CA088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D45E-44F1-8D2B-7A21A38CA088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D45E-44F1-8D2B-7A21A38CA088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D45E-44F1-8D2B-7A21A38CA088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ar-EG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 xmlns:c16r2="http://schemas.microsoft.com/office/drawing/2015/06/chart">
              <c:ext xmlns:c15="http://schemas.microsoft.com/office/drawing/2012/chart" uri="{CE6537A1-D6FC-4f65-9D91-7224C49458BB}"/>
            </c:extLst>
          </c:dLbls>
          <c:cat>
            <c:strRef>
              <c:f>ورقة1!$B$38:$G$38</c:f>
              <c:strCache>
                <c:ptCount val="6"/>
                <c:pt idx="0">
                  <c:v>∑HCH</c:v>
                </c:pt>
                <c:pt idx="1">
                  <c:v>HCB</c:v>
                </c:pt>
                <c:pt idx="2">
                  <c:v>∑HPTs</c:v>
                </c:pt>
                <c:pt idx="3">
                  <c:v>∑DRINs</c:v>
                </c:pt>
                <c:pt idx="4">
                  <c:v>∑CHLRs</c:v>
                </c:pt>
                <c:pt idx="5">
                  <c:v> ∑DDTs</c:v>
                </c:pt>
              </c:strCache>
            </c:strRef>
          </c:cat>
          <c:val>
            <c:numRef>
              <c:f>ورقة1!$B$39:$G$39</c:f>
              <c:numCache>
                <c:formatCode>0.00</c:formatCode>
                <c:ptCount val="6"/>
                <c:pt idx="0">
                  <c:v>35.526315789473685</c:v>
                </c:pt>
                <c:pt idx="1">
                  <c:v>0</c:v>
                </c:pt>
                <c:pt idx="2">
                  <c:v>27.631578947368418</c:v>
                </c:pt>
                <c:pt idx="3">
                  <c:v>11.842105263157894</c:v>
                </c:pt>
                <c:pt idx="4">
                  <c:v>3.9473684210526314</c:v>
                </c:pt>
                <c:pt idx="5">
                  <c:v>21.05263157894736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C-D45E-44F1-8D2B-7A21A38CA088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</c:pie3DChart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ar-EG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ar-EG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ar-EG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b="1" i="1" dirty="0">
                <a:solidFill>
                  <a:schemeClr val="tx1"/>
                </a:solidFill>
              </a:rPr>
              <a:t>M. </a:t>
            </a:r>
            <a:r>
              <a:rPr lang="en-US" altLang="ja-JP" b="1" i="1" dirty="0" err="1">
                <a:solidFill>
                  <a:schemeClr val="tx1"/>
                </a:solidFill>
              </a:rPr>
              <a:t>cephalus</a:t>
            </a:r>
            <a:endParaRPr lang="en-US" altLang="ja-JP" b="1" i="1" dirty="0">
              <a:solidFill>
                <a:schemeClr val="tx1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view3D>
      <c:rotX val="30"/>
      <c:rotY val="360"/>
      <c:depthPercent val="100"/>
      <c:rAngAx val="0"/>
      <c:perspective val="3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pie3DChart>
        <c:varyColors val="1"/>
        <c:ser>
          <c:idx val="0"/>
          <c:order val="0"/>
          <c:tx>
            <c:strRef>
              <c:f>ورقة1!$A$30</c:f>
              <c:strCache>
                <c:ptCount val="1"/>
                <c:pt idx="0">
                  <c:v>M. cephalus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A01A-4EF2-AB30-93E88F76D5C7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A01A-4EF2-AB30-93E88F76D5C7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A01A-4EF2-AB30-93E88F76D5C7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A01A-4EF2-AB30-93E88F76D5C7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A01A-4EF2-AB30-93E88F76D5C7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A01A-4EF2-AB30-93E88F76D5C7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ar-EG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 xmlns:c16r2="http://schemas.microsoft.com/office/drawing/2015/06/chart">
              <c:ext xmlns:c15="http://schemas.microsoft.com/office/drawing/2012/chart" uri="{CE6537A1-D6FC-4f65-9D91-7224C49458BB}"/>
            </c:extLst>
          </c:dLbls>
          <c:cat>
            <c:strRef>
              <c:f>ورقة1!$B$29:$G$29</c:f>
              <c:strCache>
                <c:ptCount val="6"/>
                <c:pt idx="0">
                  <c:v>∑HCH</c:v>
                </c:pt>
                <c:pt idx="1">
                  <c:v>HCB</c:v>
                </c:pt>
                <c:pt idx="2">
                  <c:v>∑HPTs</c:v>
                </c:pt>
                <c:pt idx="3">
                  <c:v>∑DRINs</c:v>
                </c:pt>
                <c:pt idx="4">
                  <c:v>∑CHLRs</c:v>
                </c:pt>
                <c:pt idx="5">
                  <c:v>∑DDTs</c:v>
                </c:pt>
              </c:strCache>
            </c:strRef>
          </c:cat>
          <c:val>
            <c:numRef>
              <c:f>ورقة1!$B$30:$G$30</c:f>
              <c:numCache>
                <c:formatCode>0.00</c:formatCode>
                <c:ptCount val="6"/>
                <c:pt idx="0">
                  <c:v>8.9804186360567186</c:v>
                </c:pt>
                <c:pt idx="1">
                  <c:v>6.3470627954085073</c:v>
                </c:pt>
                <c:pt idx="2">
                  <c:v>8.5752869682646864</c:v>
                </c:pt>
                <c:pt idx="3">
                  <c:v>16.070222822417286</c:v>
                </c:pt>
                <c:pt idx="4">
                  <c:v>24.24037812288994</c:v>
                </c:pt>
                <c:pt idx="5">
                  <c:v>35.78663065496285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C-A01A-4EF2-AB30-93E88F76D5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</c:pie3DChart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ar-EG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ar-EG"/>
    </a:p>
  </c:tx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ar-EG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b="1" i="1" dirty="0">
                <a:solidFill>
                  <a:schemeClr val="tx1"/>
                </a:solidFill>
              </a:rPr>
              <a:t>S. </a:t>
            </a:r>
            <a:r>
              <a:rPr lang="en-US" altLang="ja-JP" b="1" i="1" dirty="0" err="1">
                <a:solidFill>
                  <a:schemeClr val="tx1"/>
                </a:solidFill>
              </a:rPr>
              <a:t>aurita</a:t>
            </a:r>
            <a:endParaRPr lang="en-US" altLang="ja-JP" b="1" i="1" dirty="0">
              <a:solidFill>
                <a:schemeClr val="tx1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view3D>
      <c:rotX val="30"/>
      <c:rotY val="360"/>
      <c:depthPercent val="100"/>
      <c:rAngAx val="0"/>
      <c:perspective val="3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pie3DChart>
        <c:varyColors val="1"/>
        <c:ser>
          <c:idx val="0"/>
          <c:order val="0"/>
          <c:tx>
            <c:strRef>
              <c:f>ورقة1!$A$33</c:f>
              <c:strCache>
                <c:ptCount val="1"/>
                <c:pt idx="0">
                  <c:v>S. aurita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61CD-417C-B6D9-66BE031CECC9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61CD-417C-B6D9-66BE031CECC9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61CD-417C-B6D9-66BE031CECC9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61CD-417C-B6D9-66BE031CECC9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61CD-417C-B6D9-66BE031CECC9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61CD-417C-B6D9-66BE031CECC9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ar-EG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 xmlns:c16r2="http://schemas.microsoft.com/office/drawing/2015/06/chart">
              <c:ext xmlns:c15="http://schemas.microsoft.com/office/drawing/2012/chart" uri="{CE6537A1-D6FC-4f65-9D91-7224C49458BB}"/>
            </c:extLst>
          </c:dLbls>
          <c:cat>
            <c:strRef>
              <c:f>ورقة1!$B$32:$G$32</c:f>
              <c:strCache>
                <c:ptCount val="6"/>
                <c:pt idx="0">
                  <c:v>∑HCH</c:v>
                </c:pt>
                <c:pt idx="1">
                  <c:v>HCB</c:v>
                </c:pt>
                <c:pt idx="2">
                  <c:v>∑HPTs</c:v>
                </c:pt>
                <c:pt idx="3">
                  <c:v>∑DRINs</c:v>
                </c:pt>
                <c:pt idx="4">
                  <c:v>∑CHLRs</c:v>
                </c:pt>
                <c:pt idx="5">
                  <c:v>∑DDTs</c:v>
                </c:pt>
              </c:strCache>
            </c:strRef>
          </c:cat>
          <c:val>
            <c:numRef>
              <c:f>ورقة1!$B$33:$G$33</c:f>
              <c:numCache>
                <c:formatCode>0.00</c:formatCode>
                <c:ptCount val="6"/>
                <c:pt idx="0">
                  <c:v>62.345679012345677</c:v>
                </c:pt>
                <c:pt idx="1">
                  <c:v>1.5887472171625179</c:v>
                </c:pt>
                <c:pt idx="2">
                  <c:v>2.6108075288403159</c:v>
                </c:pt>
                <c:pt idx="3">
                  <c:v>0</c:v>
                </c:pt>
                <c:pt idx="4">
                  <c:v>20.724549686298321</c:v>
                </c:pt>
                <c:pt idx="5">
                  <c:v>12.7302165553531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C-61CD-417C-B6D9-66BE031CEC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</c:pie3DChart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ar-EG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ar-EG"/>
    </a:p>
  </c:txPr>
  <c:externalData r:id="rId2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6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6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6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6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6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6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ar-S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173E-01F2-473B-A3E5-22F529A551EE}" type="datetimeFigureOut">
              <a:rPr lang="ar-SA" smtClean="0"/>
              <a:t>01/04/1444</a:t>
            </a:fld>
            <a:endParaRPr lang="ar-S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61C-9A96-4720-8530-B4FA1CEE6328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1181246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S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173E-01F2-473B-A3E5-22F529A551EE}" type="datetimeFigureOut">
              <a:rPr lang="ar-SA" smtClean="0"/>
              <a:t>01/04/1444</a:t>
            </a:fld>
            <a:endParaRPr lang="ar-S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61C-9A96-4720-8530-B4FA1CEE6328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891360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S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173E-01F2-473B-A3E5-22F529A551EE}" type="datetimeFigureOut">
              <a:rPr lang="ar-SA" smtClean="0"/>
              <a:t>01/04/1444</a:t>
            </a:fld>
            <a:endParaRPr lang="ar-S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61C-9A96-4720-8530-B4FA1CEE6328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19329036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S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173E-01F2-473B-A3E5-22F529A551EE}" type="datetimeFigureOut">
              <a:rPr lang="ar-SA" smtClean="0"/>
              <a:t>01/04/1444</a:t>
            </a:fld>
            <a:endParaRPr lang="ar-S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61C-9A96-4720-8530-B4FA1CEE6328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20181878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173E-01F2-473B-A3E5-22F529A551EE}" type="datetimeFigureOut">
              <a:rPr lang="ar-SA" smtClean="0"/>
              <a:t>01/04/1444</a:t>
            </a:fld>
            <a:endParaRPr lang="ar-S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61C-9A96-4720-8530-B4FA1CEE6328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11241396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S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S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173E-01F2-473B-A3E5-22F529A551EE}" type="datetimeFigureOut">
              <a:rPr lang="ar-SA" smtClean="0"/>
              <a:t>01/04/1444</a:t>
            </a:fld>
            <a:endParaRPr lang="ar-S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61C-9A96-4720-8530-B4FA1CEE6328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26362387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S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S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173E-01F2-473B-A3E5-22F529A551EE}" type="datetimeFigureOut">
              <a:rPr lang="ar-SA" smtClean="0"/>
              <a:t>01/04/1444</a:t>
            </a:fld>
            <a:endParaRPr lang="ar-S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61C-9A96-4720-8530-B4FA1CEE6328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3447797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173E-01F2-473B-A3E5-22F529A551EE}" type="datetimeFigureOut">
              <a:rPr lang="ar-SA" smtClean="0"/>
              <a:t>01/04/1444</a:t>
            </a:fld>
            <a:endParaRPr lang="ar-S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61C-9A96-4720-8530-B4FA1CEE6328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1418956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173E-01F2-473B-A3E5-22F529A551EE}" type="datetimeFigureOut">
              <a:rPr lang="ar-SA" smtClean="0"/>
              <a:t>01/04/1444</a:t>
            </a:fld>
            <a:endParaRPr lang="ar-S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61C-9A96-4720-8530-B4FA1CEE6328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3996336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S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173E-01F2-473B-A3E5-22F529A551EE}" type="datetimeFigureOut">
              <a:rPr lang="ar-SA" smtClean="0"/>
              <a:t>01/04/1444</a:t>
            </a:fld>
            <a:endParaRPr lang="ar-S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61C-9A96-4720-8530-B4FA1CEE6328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36514216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ar-S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173E-01F2-473B-A3E5-22F529A551EE}" type="datetimeFigureOut">
              <a:rPr lang="ar-SA" smtClean="0"/>
              <a:t>01/04/1444</a:t>
            </a:fld>
            <a:endParaRPr lang="ar-S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61C-9A96-4720-8530-B4FA1CEE6328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1636518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S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47173E-01F2-473B-A3E5-22F529A551EE}" type="datetimeFigureOut">
              <a:rPr lang="ar-SA" smtClean="0"/>
              <a:t>01/04/1444</a:t>
            </a:fld>
            <a:endParaRPr lang="ar-S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ar-S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C5561C-9A96-4720-8530-B4FA1CEE6328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2680468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ar-SA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8725714"/>
              </p:ext>
            </p:extLst>
          </p:nvPr>
        </p:nvGraphicFramePr>
        <p:xfrm>
          <a:off x="-1" y="376237"/>
          <a:ext cx="4350327" cy="26765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55184264"/>
              </p:ext>
            </p:extLst>
          </p:nvPr>
        </p:nvGraphicFramePr>
        <p:xfrm>
          <a:off x="0" y="350303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31538531"/>
              </p:ext>
            </p:extLst>
          </p:nvPr>
        </p:nvGraphicFramePr>
        <p:xfrm>
          <a:off x="7883236" y="3503036"/>
          <a:ext cx="418407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6037020"/>
              </p:ext>
            </p:extLst>
          </p:nvPr>
        </p:nvGraphicFramePr>
        <p:xfrm>
          <a:off x="3810000" y="350303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1031989"/>
              </p:ext>
            </p:extLst>
          </p:nvPr>
        </p:nvGraphicFramePr>
        <p:xfrm>
          <a:off x="3810000" y="280987"/>
          <a:ext cx="4572000" cy="27717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34682103"/>
              </p:ext>
            </p:extLst>
          </p:nvPr>
        </p:nvGraphicFramePr>
        <p:xfrm>
          <a:off x="7495309" y="29527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18342042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65732" y="2277042"/>
            <a:ext cx="8103481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 concentration of OCPs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tegories among six species of fish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es. </a:t>
            </a:r>
            <a:endParaRPr lang="ar-S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83774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40</TotalTime>
  <Words>33</Words>
  <Application>Microsoft Office PowerPoint</Application>
  <PresentationFormat>Custom</PresentationFormat>
  <Paragraphs>7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lem Abdulaziz Masoud</dc:creator>
  <cp:lastModifiedBy>Password</cp:lastModifiedBy>
  <cp:revision>9</cp:revision>
  <dcterms:created xsi:type="dcterms:W3CDTF">2022-10-26T10:52:59Z</dcterms:created>
  <dcterms:modified xsi:type="dcterms:W3CDTF">2022-10-26T15:53:31Z</dcterms:modified>
</cp:coreProperties>
</file>